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8" d="100"/>
          <a:sy n="88" d="100"/>
        </p:scale>
        <p:origin x="-210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A3AA-52A0-423A-894E-CE29438E20F5}" type="datetimeFigureOut">
              <a:rPr lang="it-IT" smtClean="0"/>
              <a:pPr/>
              <a:t>27/02/2019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4DCF-D53C-4F83-9CA9-D0AFD2F48BD7}" type="slidenum">
              <a:rPr lang="it-IT" smtClean="0"/>
              <a:pPr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xmlns="" val="4176079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A3AA-52A0-423A-894E-CE29438E20F5}" type="datetimeFigureOut">
              <a:rPr lang="it-IT" smtClean="0"/>
              <a:pPr/>
              <a:t>27/02/2019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4DCF-D53C-4F83-9CA9-D0AFD2F48BD7}" type="slidenum">
              <a:rPr lang="it-IT" smtClean="0"/>
              <a:pPr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xmlns="" val="3206913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A3AA-52A0-423A-894E-CE29438E20F5}" type="datetimeFigureOut">
              <a:rPr lang="it-IT" smtClean="0"/>
              <a:pPr/>
              <a:t>27/02/2019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4DCF-D53C-4F83-9CA9-D0AFD2F48BD7}" type="slidenum">
              <a:rPr lang="it-IT" smtClean="0"/>
              <a:pPr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xmlns="" val="2907227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A3AA-52A0-423A-894E-CE29438E20F5}" type="datetimeFigureOut">
              <a:rPr lang="it-IT" smtClean="0"/>
              <a:pPr/>
              <a:t>27/02/2019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4DCF-D53C-4F83-9CA9-D0AFD2F48BD7}" type="slidenum">
              <a:rPr lang="it-IT" smtClean="0"/>
              <a:pPr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xmlns="" val="2893553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A3AA-52A0-423A-894E-CE29438E20F5}" type="datetimeFigureOut">
              <a:rPr lang="it-IT" smtClean="0"/>
              <a:pPr/>
              <a:t>27/02/2019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4DCF-D53C-4F83-9CA9-D0AFD2F48BD7}" type="slidenum">
              <a:rPr lang="it-IT" smtClean="0"/>
              <a:pPr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xmlns="" val="2874490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A3AA-52A0-423A-894E-CE29438E20F5}" type="datetimeFigureOut">
              <a:rPr lang="it-IT" smtClean="0"/>
              <a:pPr/>
              <a:t>27/02/2019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4DCF-D53C-4F83-9CA9-D0AFD2F48BD7}" type="slidenum">
              <a:rPr lang="it-IT" smtClean="0"/>
              <a:pPr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xmlns="" val="1652693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A3AA-52A0-423A-894E-CE29438E20F5}" type="datetimeFigureOut">
              <a:rPr lang="it-IT" smtClean="0"/>
              <a:pPr/>
              <a:t>27/02/2019</a:t>
            </a:fld>
            <a:endParaRPr lang="it-IT" dirty="0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4DCF-D53C-4F83-9CA9-D0AFD2F48BD7}" type="slidenum">
              <a:rPr lang="it-IT" smtClean="0"/>
              <a:pPr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xmlns="" val="1988533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A3AA-52A0-423A-894E-CE29438E20F5}" type="datetimeFigureOut">
              <a:rPr lang="it-IT" smtClean="0"/>
              <a:pPr/>
              <a:t>27/02/2019</a:t>
            </a:fld>
            <a:endParaRPr lang="it-IT" dirty="0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4DCF-D53C-4F83-9CA9-D0AFD2F48BD7}" type="slidenum">
              <a:rPr lang="it-IT" smtClean="0"/>
              <a:pPr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xmlns="" val="3077235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A3AA-52A0-423A-894E-CE29438E20F5}" type="datetimeFigureOut">
              <a:rPr lang="it-IT" smtClean="0"/>
              <a:pPr/>
              <a:t>27/02/2019</a:t>
            </a:fld>
            <a:endParaRPr lang="it-IT" dirty="0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4DCF-D53C-4F83-9CA9-D0AFD2F48BD7}" type="slidenum">
              <a:rPr lang="it-IT" smtClean="0"/>
              <a:pPr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xmlns="" val="21426676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A3AA-52A0-423A-894E-CE29438E20F5}" type="datetimeFigureOut">
              <a:rPr lang="it-IT" smtClean="0"/>
              <a:pPr/>
              <a:t>27/02/2019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4DCF-D53C-4F83-9CA9-D0AFD2F48BD7}" type="slidenum">
              <a:rPr lang="it-IT" smtClean="0"/>
              <a:pPr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xmlns="" val="530921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 dirty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9A3AA-52A0-423A-894E-CE29438E20F5}" type="datetimeFigureOut">
              <a:rPr lang="it-IT" smtClean="0"/>
              <a:pPr/>
              <a:t>27/02/2019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3B4DCF-D53C-4F83-9CA9-D0AFD2F48BD7}" type="slidenum">
              <a:rPr lang="it-IT" smtClean="0"/>
              <a:pPr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xmlns="" val="802037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9A3AA-52A0-423A-894E-CE29438E20F5}" type="datetimeFigureOut">
              <a:rPr lang="it-IT" smtClean="0"/>
              <a:pPr/>
              <a:t>27/02/2019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3B4DCF-D53C-4F83-9CA9-D0AFD2F48BD7}" type="slidenum">
              <a:rPr lang="it-IT" smtClean="0"/>
              <a:pPr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xmlns="" val="4169246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47939" y="604839"/>
            <a:ext cx="7096125" cy="6191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CasellaDiTesto 1"/>
          <p:cNvSpPr txBox="1"/>
          <p:nvPr/>
        </p:nvSpPr>
        <p:spPr>
          <a:xfrm>
            <a:off x="66786" y="202570"/>
            <a:ext cx="61991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S1 Appendix. Representative FACS plot of purity of </a:t>
            </a:r>
            <a:r>
              <a:rPr lang="en-US" sz="1100" b="1" dirty="0" smtClean="0"/>
              <a:t>BM </a:t>
            </a:r>
            <a:r>
              <a:rPr lang="en-US" sz="1100" b="1" dirty="0" err="1" smtClean="0"/>
              <a:t>CD34</a:t>
            </a:r>
            <a:r>
              <a:rPr lang="en-US" sz="1100" b="1" dirty="0" smtClean="0"/>
              <a:t>+/lin- cells determined by flow cytometry. </a:t>
            </a:r>
            <a:endParaRPr lang="it-IT" sz="1100" b="1" dirty="0"/>
          </a:p>
        </p:txBody>
      </p:sp>
    </p:spTree>
    <p:extLst>
      <p:ext uri="{BB962C8B-B14F-4D97-AF65-F5344CB8AC3E}">
        <p14:creationId xmlns:p14="http://schemas.microsoft.com/office/powerpoint/2010/main" xmlns="" val="10964261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9</Words>
  <Application>Microsoft Office PowerPoint</Application>
  <PresentationFormat>Personalizzato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>H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HP</dc:creator>
  <cp:lastModifiedBy>atrojani</cp:lastModifiedBy>
  <cp:revision>4</cp:revision>
  <dcterms:created xsi:type="dcterms:W3CDTF">2019-02-25T11:07:20Z</dcterms:created>
  <dcterms:modified xsi:type="dcterms:W3CDTF">2019-02-27T14:52:30Z</dcterms:modified>
</cp:coreProperties>
</file>